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5.png" ContentType="image/png"/>
  <Override PartName="/ppt/media/image10.png" ContentType="image/png"/>
  <Override PartName="/ppt/media/image2.jpeg" ContentType="image/jpeg"/>
  <Override PartName="/ppt/media/image3.jpeg" ContentType="image/jpeg"/>
  <Override PartName="/ppt/media/image4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022531-A10C-43FC-8C6E-D70D3ECF504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576A9E-EC66-4AE4-BE4B-CB1D112C5F8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5569A6-DE30-4E86-82E9-1F221D4C597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C2DAB7-64E0-4492-A884-1FEA56F858F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A1760B-C8C0-491F-AF23-D33852A24B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85458B-09D7-43B4-9367-D315AC515D0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26A424-9B73-4374-AEA0-03A895391A4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4196FC-99BE-449F-84F8-71E54B0DCC8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CFE0AF-C218-4671-8E0B-6F2C9F5F1B1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E9A730-F103-41A0-91E4-B2AB84A53AA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D2D8EA-0258-4A93-B54D-A24503FC81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65F11B-FE6C-4460-ADFF-826C73EE4F9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E92DDF9-86AB-490A-830E-5CAF4D6202DF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06F8ED6-1579-4827-A104-F9954123CAB3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278000" y="192240"/>
            <a:ext cx="6328800" cy="4564080"/>
            <a:chOff x="1278000" y="192240"/>
            <a:chExt cx="6328800" cy="4564080"/>
          </a:xfrm>
        </p:grpSpPr>
        <p:pic>
          <p:nvPicPr>
            <p:cNvPr id="42" name="Picture 6" descr="Sbi4_surface_helix2b.jpg                                       008389C0Macintosh HD                   BCDAE01C:"/>
            <p:cNvPicPr/>
            <p:nvPr/>
          </p:nvPicPr>
          <p:blipFill>
            <a:blip r:embed="rId1"/>
            <a:srcRect l="18731" t="11239" r="19669" b="0"/>
            <a:stretch/>
          </p:blipFill>
          <p:spPr>
            <a:xfrm>
              <a:off x="1584720" y="192240"/>
              <a:ext cx="1413720" cy="2037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Text Box 13"/>
            <p:cNvSpPr/>
            <p:nvPr/>
          </p:nvSpPr>
          <p:spPr>
            <a:xfrm>
              <a:off x="2325960" y="1400760"/>
              <a:ext cx="266040" cy="274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ffffff"/>
                  </a:solidFill>
                  <a:latin typeface="Calibri"/>
                </a:rPr>
                <a:t>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Text Box 14"/>
            <p:cNvSpPr/>
            <p:nvPr/>
          </p:nvSpPr>
          <p:spPr>
            <a:xfrm>
              <a:off x="2147040" y="1041480"/>
              <a:ext cx="282600" cy="274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ffffff"/>
                  </a:solidFill>
                  <a:latin typeface="Calibri"/>
                </a:rPr>
                <a:t>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5" name="Picture 2" descr="Efb_surface_helix2.jpg                                         008389C0Macintosh HD                   BCDAE01C:"/>
            <p:cNvPicPr/>
            <p:nvPr/>
          </p:nvPicPr>
          <p:blipFill>
            <a:blip r:embed="rId2"/>
            <a:srcRect l="0" t="10822" r="0" b="0"/>
            <a:stretch/>
          </p:blipFill>
          <p:spPr>
            <a:xfrm>
              <a:off x="3266280" y="192240"/>
              <a:ext cx="2295000" cy="2046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6" name="Text Box 3"/>
            <p:cNvSpPr/>
            <p:nvPr/>
          </p:nvSpPr>
          <p:spPr>
            <a:xfrm>
              <a:off x="3585240" y="2145960"/>
              <a:ext cx="48384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Ef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 Box 9"/>
            <p:cNvSpPr/>
            <p:nvPr/>
          </p:nvSpPr>
          <p:spPr>
            <a:xfrm>
              <a:off x="4494600" y="1490400"/>
              <a:ext cx="266040" cy="274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ffffff"/>
                  </a:solidFill>
                  <a:latin typeface="Calibri"/>
                </a:rPr>
                <a:t>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 Box 10"/>
            <p:cNvSpPr/>
            <p:nvPr/>
          </p:nvSpPr>
          <p:spPr>
            <a:xfrm>
              <a:off x="4142880" y="1123560"/>
              <a:ext cx="282600" cy="274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ffffff"/>
                  </a:solidFill>
                  <a:latin typeface="Calibri"/>
                </a:rPr>
                <a:t>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Rectangle 10"/>
            <p:cNvSpPr/>
            <p:nvPr/>
          </p:nvSpPr>
          <p:spPr>
            <a:xfrm>
              <a:off x="1278000" y="2179080"/>
              <a:ext cx="71856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Sbi-IV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0" name="Picture 4" descr="Ehp_surface_helix2.jpg                                         008389C0Macintosh HD                   BCDAE01C:"/>
            <p:cNvPicPr/>
            <p:nvPr/>
          </p:nvPicPr>
          <p:blipFill>
            <a:blip r:embed="rId3"/>
            <a:srcRect l="0" t="10199" r="0" b="0"/>
            <a:stretch/>
          </p:blipFill>
          <p:spPr>
            <a:xfrm>
              <a:off x="5311800" y="192240"/>
              <a:ext cx="2295000" cy="2061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1" name="Text Box 5"/>
            <p:cNvSpPr/>
            <p:nvPr/>
          </p:nvSpPr>
          <p:spPr>
            <a:xfrm>
              <a:off x="5635440" y="2145960"/>
              <a:ext cx="53568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Ehp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 Box 11"/>
            <p:cNvSpPr/>
            <p:nvPr/>
          </p:nvSpPr>
          <p:spPr>
            <a:xfrm>
              <a:off x="6669000" y="1383840"/>
              <a:ext cx="266040" cy="274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ffffff"/>
                  </a:solidFill>
                  <a:latin typeface="Calibri"/>
                </a:rPr>
                <a:t>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 Box 12"/>
            <p:cNvSpPr/>
            <p:nvPr/>
          </p:nvSpPr>
          <p:spPr>
            <a:xfrm>
              <a:off x="6310080" y="964800"/>
              <a:ext cx="282600" cy="274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ffffff"/>
                  </a:solidFill>
                  <a:latin typeface="Calibri"/>
                </a:rPr>
                <a:t>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4" name="Picture 15" descr="Sbi4_surface_helix13.rgb"/>
            <p:cNvPicPr/>
            <p:nvPr/>
          </p:nvPicPr>
          <p:blipFill>
            <a:blip r:embed="rId4"/>
            <a:srcRect l="22295" t="0" r="16150" b="0"/>
            <a:stretch/>
          </p:blipFill>
          <p:spPr>
            <a:xfrm>
              <a:off x="1719360" y="2441880"/>
              <a:ext cx="1412640" cy="2295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5" name="Rectangle 16"/>
            <p:cNvSpPr/>
            <p:nvPr/>
          </p:nvSpPr>
          <p:spPr>
            <a:xfrm>
              <a:off x="2639880" y="4205520"/>
              <a:ext cx="42912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α1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17"/>
            <p:cNvSpPr/>
            <p:nvPr/>
          </p:nvSpPr>
          <p:spPr>
            <a:xfrm>
              <a:off x="1768680" y="2986560"/>
              <a:ext cx="42912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α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Rectangle 18"/>
            <p:cNvSpPr/>
            <p:nvPr/>
          </p:nvSpPr>
          <p:spPr>
            <a:xfrm>
              <a:off x="1719000" y="525600"/>
              <a:ext cx="42912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α2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8" name="Picture 19" descr="Efb_helix13surface_elec.rgb"/>
            <p:cNvPicPr/>
            <p:nvPr/>
          </p:nvPicPr>
          <p:blipFill>
            <a:blip r:embed="rId5"/>
            <a:srcRect l="21081" t="0" r="14420" b="0"/>
            <a:stretch/>
          </p:blipFill>
          <p:spPr>
            <a:xfrm>
              <a:off x="3734280" y="2430000"/>
              <a:ext cx="1480680" cy="2295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9" name="Picture 20" descr="Ehp_helix13surface_elec.rgb"/>
            <p:cNvPicPr/>
            <p:nvPr/>
          </p:nvPicPr>
          <p:blipFill>
            <a:blip r:embed="rId6"/>
            <a:srcRect l="7762" t="0" r="14108" b="0"/>
            <a:stretch/>
          </p:blipFill>
          <p:spPr>
            <a:xfrm>
              <a:off x="5561280" y="2461320"/>
              <a:ext cx="1793880" cy="2295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0" name="Curved Left Arrow 21"/>
            <p:cNvSpPr/>
            <p:nvPr/>
          </p:nvSpPr>
          <p:spPr>
            <a:xfrm>
              <a:off x="2608200" y="2227320"/>
              <a:ext cx="341280" cy="405720"/>
            </a:xfrm>
            <a:custGeom>
              <a:avLst/>
              <a:gdLst>
                <a:gd name="textAreaLeft" fmla="*/ 45720 w 341280"/>
                <a:gd name="textAreaRight" fmla="*/ 295560 w 341280"/>
                <a:gd name="textAreaTop" fmla="*/ 69480 h 405720"/>
                <a:gd name="textAreaBottom" fmla="*/ 293760 h 4057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arcTo wR="21600" hR="7393" stAng="-5400000" swAng="5400000"/>
                  <a:lnTo>
                    <a:pt x="21600" y="11936"/>
                  </a:lnTo>
                  <a:arcTo wR="21600" hR="7393" stAng="0" swAng="3178200"/>
                  <a:lnTo>
                    <a:pt x="5400" y="21365"/>
                  </a:lnTo>
                  <a:lnTo>
                    <a:pt x="0" y="17058"/>
                  </a:lnTo>
                  <a:lnTo>
                    <a:pt x="5400" y="12280"/>
                  </a:lnTo>
                  <a:lnTo>
                    <a:pt x="5400" y="14551"/>
                  </a:lnTo>
                  <a:arcTo wR="21600" hR="7393" stAng="3178200" swAng="-2799839"/>
                  <a:lnTo>
                    <a:pt x="20555" y="9665"/>
                  </a:lnTo>
                  <a:arcTo wR="21600" hR="7393" stAng="-378361" swAng="-5021639"/>
                  <a:close/>
                </a:path>
                <a:path fill="darkenLess" w="21600" h="21600">
                  <a:moveTo>
                    <a:pt x="0" y="0"/>
                  </a:moveTo>
                  <a:arcTo wR="21600" hR="7393" stAng="-5400000" swAng="5400000"/>
                  <a:lnTo>
                    <a:pt x="21600" y="11936"/>
                  </a:lnTo>
                  <a:arcTo wR="21600" hR="7393" stAng="0" swAng="-378361"/>
                  <a:lnTo>
                    <a:pt x="20555" y="9665"/>
                  </a:lnTo>
                  <a:arcTo wR="21600" hR="7393" stAng="-378361" swAng="-5021639"/>
                  <a:close/>
                </a:path>
              </a:pathLst>
            </a:custGeom>
            <a:gradFill rotWithShape="0">
              <a:gsLst>
                <a:gs pos="0">
                  <a:srgbClr val="9bc1ff"/>
                </a:gs>
                <a:gs pos="100000">
                  <a:srgbClr val="3f80cd"/>
                </a:gs>
              </a:gsLst>
              <a:lin ang="5400000"/>
            </a:gradFill>
            <a:ln w="9360">
              <a:solidFill>
                <a:srgbClr val="4a7ebb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Curved Left Arrow 22"/>
            <p:cNvSpPr/>
            <p:nvPr/>
          </p:nvSpPr>
          <p:spPr>
            <a:xfrm>
              <a:off x="4624200" y="2253600"/>
              <a:ext cx="341280" cy="405720"/>
            </a:xfrm>
            <a:custGeom>
              <a:avLst/>
              <a:gdLst>
                <a:gd name="textAreaLeft" fmla="*/ 45720 w 341280"/>
                <a:gd name="textAreaRight" fmla="*/ 295560 w 341280"/>
                <a:gd name="textAreaTop" fmla="*/ 69480 h 405720"/>
                <a:gd name="textAreaBottom" fmla="*/ 293760 h 4057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arcTo wR="21600" hR="7393" stAng="-5400000" swAng="5400000"/>
                  <a:lnTo>
                    <a:pt x="21600" y="11936"/>
                  </a:lnTo>
                  <a:arcTo wR="21600" hR="7393" stAng="0" swAng="3178200"/>
                  <a:lnTo>
                    <a:pt x="5400" y="21365"/>
                  </a:lnTo>
                  <a:lnTo>
                    <a:pt x="0" y="17058"/>
                  </a:lnTo>
                  <a:lnTo>
                    <a:pt x="5400" y="12280"/>
                  </a:lnTo>
                  <a:lnTo>
                    <a:pt x="5400" y="14551"/>
                  </a:lnTo>
                  <a:arcTo wR="21600" hR="7393" stAng="3178200" swAng="-2799839"/>
                  <a:lnTo>
                    <a:pt x="20555" y="9665"/>
                  </a:lnTo>
                  <a:arcTo wR="21600" hR="7393" stAng="-378361" swAng="-5021639"/>
                  <a:close/>
                </a:path>
                <a:path fill="darkenLess" w="21600" h="21600">
                  <a:moveTo>
                    <a:pt x="0" y="0"/>
                  </a:moveTo>
                  <a:arcTo wR="21600" hR="7393" stAng="-5400000" swAng="5400000"/>
                  <a:lnTo>
                    <a:pt x="21600" y="11936"/>
                  </a:lnTo>
                  <a:arcTo wR="21600" hR="7393" stAng="0" swAng="-378361"/>
                  <a:lnTo>
                    <a:pt x="20555" y="9665"/>
                  </a:lnTo>
                  <a:arcTo wR="21600" hR="7393" stAng="-378361" swAng="-5021639"/>
                  <a:close/>
                </a:path>
              </a:pathLst>
            </a:custGeom>
            <a:gradFill rotWithShape="0">
              <a:gsLst>
                <a:gs pos="0">
                  <a:srgbClr val="9bc1ff"/>
                </a:gs>
                <a:gs pos="100000">
                  <a:srgbClr val="3f80cd"/>
                </a:gs>
              </a:gsLst>
              <a:lin ang="5400000"/>
            </a:gradFill>
            <a:ln w="9360">
              <a:solidFill>
                <a:srgbClr val="4a7ebb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Curved Left Arrow 23"/>
            <p:cNvSpPr/>
            <p:nvPr/>
          </p:nvSpPr>
          <p:spPr>
            <a:xfrm>
              <a:off x="6884640" y="2227320"/>
              <a:ext cx="341640" cy="405720"/>
            </a:xfrm>
            <a:custGeom>
              <a:avLst/>
              <a:gdLst>
                <a:gd name="textAreaLeft" fmla="*/ 45720 w 341640"/>
                <a:gd name="textAreaRight" fmla="*/ 295920 w 341640"/>
                <a:gd name="textAreaTop" fmla="*/ 69480 h 405720"/>
                <a:gd name="textAreaBottom" fmla="*/ 293760 h 4057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arcTo wR="21600" hR="7393" stAng="-5400000" swAng="5400000"/>
                  <a:lnTo>
                    <a:pt x="21600" y="11936"/>
                  </a:lnTo>
                  <a:arcTo wR="21600" hR="7393" stAng="0" swAng="3178200"/>
                  <a:lnTo>
                    <a:pt x="5400" y="21365"/>
                  </a:lnTo>
                  <a:lnTo>
                    <a:pt x="0" y="17058"/>
                  </a:lnTo>
                  <a:lnTo>
                    <a:pt x="5400" y="12280"/>
                  </a:lnTo>
                  <a:lnTo>
                    <a:pt x="5400" y="14551"/>
                  </a:lnTo>
                  <a:arcTo wR="21600" hR="7393" stAng="3178200" swAng="-2799839"/>
                  <a:lnTo>
                    <a:pt x="20555" y="9665"/>
                  </a:lnTo>
                  <a:arcTo wR="21600" hR="7393" stAng="-378361" swAng="-5021639"/>
                  <a:close/>
                </a:path>
                <a:path fill="darkenLess" w="21600" h="21600">
                  <a:moveTo>
                    <a:pt x="0" y="0"/>
                  </a:moveTo>
                  <a:arcTo wR="21600" hR="7393" stAng="-5400000" swAng="5400000"/>
                  <a:lnTo>
                    <a:pt x="21600" y="11936"/>
                  </a:lnTo>
                  <a:arcTo wR="21600" hR="7393" stAng="0" swAng="-378361"/>
                  <a:lnTo>
                    <a:pt x="20555" y="9665"/>
                  </a:lnTo>
                  <a:arcTo wR="21600" hR="7393" stAng="-378361" swAng="-5021639"/>
                  <a:close/>
                </a:path>
              </a:pathLst>
            </a:custGeom>
            <a:gradFill rotWithShape="0">
              <a:gsLst>
                <a:gs pos="0">
                  <a:srgbClr val="9bc1ff"/>
                </a:gs>
                <a:gs pos="100000">
                  <a:srgbClr val="3f80cd"/>
                </a:gs>
              </a:gsLst>
              <a:lin ang="5400000"/>
            </a:gradFill>
            <a:ln w="9360">
              <a:solidFill>
                <a:srgbClr val="4a7ebb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Straight Connector 30"/>
            <p:cNvSpPr/>
            <p:nvPr/>
          </p:nvSpPr>
          <p:spPr>
            <a:xfrm>
              <a:off x="2768400" y="2145960"/>
              <a:ext cx="9720" cy="284040"/>
            </a:xfrm>
            <a:prstGeom prst="line">
              <a:avLst/>
            </a:prstGeom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Straight Connector 31"/>
            <p:cNvSpPr/>
            <p:nvPr/>
          </p:nvSpPr>
          <p:spPr>
            <a:xfrm>
              <a:off x="4793760" y="2157840"/>
              <a:ext cx="9720" cy="284040"/>
            </a:xfrm>
            <a:prstGeom prst="line">
              <a:avLst/>
            </a:prstGeom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Straight Connector 32"/>
            <p:cNvSpPr/>
            <p:nvPr/>
          </p:nvSpPr>
          <p:spPr>
            <a:xfrm>
              <a:off x="7049520" y="2145960"/>
              <a:ext cx="9360" cy="284040"/>
            </a:xfrm>
            <a:prstGeom prst="line">
              <a:avLst/>
            </a:prstGeom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6" name=""/>
          <p:cNvSpPr/>
          <p:nvPr/>
        </p:nvSpPr>
        <p:spPr>
          <a:xfrm>
            <a:off x="52560" y="5041800"/>
            <a:ext cx="9144000" cy="1691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9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500" spc="-1" strike="noStrike">
                <a:solidFill>
                  <a:srgbClr val="000000"/>
                </a:solidFill>
                <a:latin typeface="Arial"/>
              </a:rPr>
              <a:t>Supporting Figure 1.</a:t>
            </a:r>
            <a:r>
              <a:rPr b="0" i="1" lang="en-US" sz="1500" spc="-1" strike="noStrike">
                <a:solidFill>
                  <a:srgbClr val="000000"/>
                </a:solidFill>
                <a:latin typeface="Arial"/>
              </a:rPr>
              <a:t> Surface charge of Sbi-IV in comparison with staphylococcal complement evasion proteins Efb-C and Ehp. Molecular surface representations of Sbi-IV, Efb-C and Ehp in their complexes with C3d (respective PDB accession codes for Efb-C and Ehp complexes with C3d: 2GOX and 2NOJ), with the top panel showing the α2 surface of each molecule and the bottom panel showing the α1-α3 surface.</a:t>
            </a:r>
            <a:r>
              <a:rPr b="1" i="1" lang="en-US" sz="1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en-US" sz="1500" spc="-1" strike="noStrike">
                <a:solidFill>
                  <a:srgbClr val="000000"/>
                </a:solidFill>
                <a:latin typeface="Arial"/>
              </a:rPr>
              <a:t>While both Efb-C and Ehp display a highly charged molecular surface at both α2 and α1-α3 surfaces, the α1- α3 surface of Sbi-IV is mainly hydrophobic and highly compatible with the convex surface of C3d.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7" name="Group 19"/>
          <p:cNvGrpSpPr/>
          <p:nvPr/>
        </p:nvGrpSpPr>
        <p:grpSpPr>
          <a:xfrm>
            <a:off x="3092400" y="0"/>
            <a:ext cx="4070520" cy="5322960"/>
            <a:chOff x="3092400" y="0"/>
            <a:chExt cx="4070520" cy="5322960"/>
          </a:xfrm>
        </p:grpSpPr>
        <p:pic>
          <p:nvPicPr>
            <p:cNvPr id="68" name="Picture 4" descr=""/>
            <p:cNvPicPr/>
            <p:nvPr/>
          </p:nvPicPr>
          <p:blipFill>
            <a:blip r:embed="rId1"/>
            <a:stretch/>
          </p:blipFill>
          <p:spPr>
            <a:xfrm>
              <a:off x="3092400" y="0"/>
              <a:ext cx="3533400" cy="5322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9" name="TextBox 3"/>
            <p:cNvSpPr/>
            <p:nvPr/>
          </p:nvSpPr>
          <p:spPr>
            <a:xfrm>
              <a:off x="6113160" y="1212840"/>
              <a:ext cx="83916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Sbi-E : C3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Box 5"/>
            <p:cNvSpPr/>
            <p:nvPr/>
          </p:nvSpPr>
          <p:spPr>
            <a:xfrm>
              <a:off x="6112080" y="1679400"/>
              <a:ext cx="105084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Sbi-III-IV : C3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TextBox 6"/>
            <p:cNvSpPr/>
            <p:nvPr/>
          </p:nvSpPr>
          <p:spPr>
            <a:xfrm>
              <a:off x="6112440" y="2165400"/>
              <a:ext cx="88956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Sbi-IV : C3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TextBox 8"/>
            <p:cNvSpPr/>
            <p:nvPr/>
          </p:nvSpPr>
          <p:spPr>
            <a:xfrm>
              <a:off x="6114600" y="2765520"/>
              <a:ext cx="42012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C3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TextBox 9"/>
            <p:cNvSpPr/>
            <p:nvPr/>
          </p:nvSpPr>
          <p:spPr>
            <a:xfrm>
              <a:off x="6113520" y="3079800"/>
              <a:ext cx="431640" cy="45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Sbi-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Rounded Rectangle 10"/>
            <p:cNvSpPr/>
            <p:nvPr/>
          </p:nvSpPr>
          <p:spPr>
            <a:xfrm>
              <a:off x="5798880" y="1008720"/>
              <a:ext cx="596520" cy="146880"/>
            </a:xfrm>
            <a:prstGeom prst="roundRect">
              <a:avLst>
                <a:gd name="adj" fmla="val 16667"/>
              </a:avLst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Rounded Rectangle 11"/>
            <p:cNvSpPr/>
            <p:nvPr/>
          </p:nvSpPr>
          <p:spPr>
            <a:xfrm>
              <a:off x="5772240" y="1473480"/>
              <a:ext cx="705960" cy="146880"/>
            </a:xfrm>
            <a:prstGeom prst="roundRect">
              <a:avLst>
                <a:gd name="adj" fmla="val 16667"/>
              </a:avLst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Rounded Rectangle 12"/>
            <p:cNvSpPr/>
            <p:nvPr/>
          </p:nvSpPr>
          <p:spPr>
            <a:xfrm>
              <a:off x="5805000" y="2052720"/>
              <a:ext cx="597960" cy="146880"/>
            </a:xfrm>
            <a:prstGeom prst="roundRect">
              <a:avLst>
                <a:gd name="adj" fmla="val 16667"/>
              </a:avLst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Rounded Rectangle 13"/>
            <p:cNvSpPr/>
            <p:nvPr/>
          </p:nvSpPr>
          <p:spPr>
            <a:xfrm>
              <a:off x="5784840" y="2605680"/>
              <a:ext cx="361800" cy="146880"/>
            </a:xfrm>
            <a:prstGeom prst="roundRect">
              <a:avLst>
                <a:gd name="adj" fmla="val 16667"/>
              </a:avLst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Rounded Rectangle 14"/>
            <p:cNvSpPr/>
            <p:nvPr/>
          </p:nvSpPr>
          <p:spPr>
            <a:xfrm>
              <a:off x="5798880" y="3031560"/>
              <a:ext cx="335160" cy="126720"/>
            </a:xfrm>
            <a:prstGeom prst="roundRect">
              <a:avLst>
                <a:gd name="adj" fmla="val 16667"/>
              </a:avLst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Rounded Rectangle 15"/>
            <p:cNvSpPr/>
            <p:nvPr/>
          </p:nvSpPr>
          <p:spPr>
            <a:xfrm>
              <a:off x="5792400" y="3507480"/>
              <a:ext cx="380520" cy="146880"/>
            </a:xfrm>
            <a:prstGeom prst="roundRect">
              <a:avLst>
                <a:gd name="adj" fmla="val 16667"/>
              </a:avLst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TextBox 16"/>
            <p:cNvSpPr/>
            <p:nvPr/>
          </p:nvSpPr>
          <p:spPr>
            <a:xfrm>
              <a:off x="6113520" y="3640320"/>
              <a:ext cx="682560" cy="45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Sbi-III-IV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TextBox 17"/>
            <p:cNvSpPr/>
            <p:nvPr/>
          </p:nvSpPr>
          <p:spPr>
            <a:xfrm>
              <a:off x="6113520" y="4125960"/>
              <a:ext cx="431640" cy="45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Sbi-IV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Rounded Rectangle 18"/>
            <p:cNvSpPr/>
            <p:nvPr/>
          </p:nvSpPr>
          <p:spPr>
            <a:xfrm>
              <a:off x="5753520" y="3952440"/>
              <a:ext cx="380520" cy="146880"/>
            </a:xfrm>
            <a:prstGeom prst="roundRect">
              <a:avLst>
                <a:gd name="adj" fmla="val 16667"/>
              </a:avLst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3" name=""/>
          <p:cNvSpPr/>
          <p:nvPr/>
        </p:nvSpPr>
        <p:spPr>
          <a:xfrm>
            <a:off x="0" y="5322960"/>
            <a:ext cx="9144000" cy="1463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9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500" spc="-1" strike="noStrike">
                <a:solidFill>
                  <a:srgbClr val="000000"/>
                </a:solidFill>
                <a:latin typeface="Arial"/>
              </a:rPr>
              <a:t>Supporting Figure 2.</a:t>
            </a:r>
            <a:r>
              <a:rPr b="0" i="1" lang="en-US" sz="1500" spc="-1" strike="noStrike">
                <a:solidFill>
                  <a:srgbClr val="000000"/>
                </a:solidFill>
                <a:latin typeface="Arial"/>
              </a:rPr>
              <a:t> SAXS data of C3d, Sbi-E, its partial constructs and their complexes with C3d. Experimental data are shown by dots; fitting curves are displayed as solid lines. Scattering curves are displaced by multiplying intensities by a factor of 20 (Sbi-IV curve is not multiplied). Magenta lines represent ab initio fits by DAMMIF, red lines represent fits by CRYSOL. For Sbi-IV:C3d and Sbi-III-IV:C3d complexes, red lines represent correspondingly CRYSOL and rigid body fits from complex 1-type models; corresponding fits to complex 2-type models are shown as blue lines.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4" name=""/>
          <p:cNvGrpSpPr/>
          <p:nvPr/>
        </p:nvGrpSpPr>
        <p:grpSpPr>
          <a:xfrm>
            <a:off x="1724400" y="982800"/>
            <a:ext cx="5005080" cy="2998800"/>
            <a:chOff x="1724400" y="982800"/>
            <a:chExt cx="5005080" cy="2998800"/>
          </a:xfrm>
        </p:grpSpPr>
        <p:pic>
          <p:nvPicPr>
            <p:cNvPr id="85" name="Picture 11" descr="mov0027.png"/>
            <p:cNvPicPr/>
            <p:nvPr/>
          </p:nvPicPr>
          <p:blipFill>
            <a:blip r:embed="rId1"/>
            <a:srcRect l="28258" t="0" r="2298" b="16855"/>
            <a:stretch/>
          </p:blipFill>
          <p:spPr>
            <a:xfrm>
              <a:off x="2408400" y="982800"/>
              <a:ext cx="4321080" cy="2998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6" name="TextBox 10"/>
            <p:cNvSpPr/>
            <p:nvPr/>
          </p:nvSpPr>
          <p:spPr>
            <a:xfrm>
              <a:off x="5980680" y="2203560"/>
              <a:ext cx="54792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800" spc="-1" strike="noStrike">
                  <a:solidFill>
                    <a:srgbClr val="660066"/>
                  </a:solidFill>
                  <a:latin typeface="Calibri"/>
                </a:rPr>
                <a:t>CR2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TextBox 11"/>
            <p:cNvSpPr/>
            <p:nvPr/>
          </p:nvSpPr>
          <p:spPr>
            <a:xfrm>
              <a:off x="4606920" y="1683000"/>
              <a:ext cx="54756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800" spc="-1" strike="noStrike">
                  <a:solidFill>
                    <a:srgbClr val="696969"/>
                  </a:solidFill>
                  <a:latin typeface="Calibri"/>
                </a:rPr>
                <a:t>Zn</a:t>
              </a:r>
              <a:r>
                <a:rPr b="1" lang="en-US" sz="1800" spc="-1" strike="noStrike" baseline="30000">
                  <a:solidFill>
                    <a:srgbClr val="696969"/>
                  </a:solidFill>
                  <a:latin typeface="Calibri"/>
                </a:rPr>
                <a:t>2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TextBox 13"/>
            <p:cNvSpPr/>
            <p:nvPr/>
          </p:nvSpPr>
          <p:spPr>
            <a:xfrm>
              <a:off x="1724400" y="2387880"/>
              <a:ext cx="54180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800" spc="-1" strike="noStrike">
                  <a:solidFill>
                    <a:srgbClr val="008000"/>
                  </a:solidFill>
                  <a:latin typeface="Calibri"/>
                </a:rPr>
                <a:t>C3d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TextBox 6"/>
            <p:cNvSpPr/>
            <p:nvPr/>
          </p:nvSpPr>
          <p:spPr>
            <a:xfrm>
              <a:off x="5230440" y="1244880"/>
              <a:ext cx="80388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800" spc="-1" strike="noStrike">
                  <a:solidFill>
                    <a:srgbClr val="ff0000"/>
                  </a:solidFill>
                  <a:latin typeface="Calibri"/>
                </a:rPr>
                <a:t>Sbi-IV</a:t>
              </a:r>
              <a:r>
                <a:rPr b="1" lang="en-US" sz="1800" spc="-1" strike="noStrike" baseline="30000">
                  <a:solidFill>
                    <a:srgbClr val="ff0000"/>
                  </a:solidFill>
                  <a:latin typeface="Calibri"/>
                </a:rPr>
                <a:t>1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0" name=""/>
          <p:cNvSpPr/>
          <p:nvPr/>
        </p:nvSpPr>
        <p:spPr>
          <a:xfrm>
            <a:off x="157320" y="4487760"/>
            <a:ext cx="8986680" cy="12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9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500" spc="-1" strike="noStrike">
                <a:solidFill>
                  <a:srgbClr val="000000"/>
                </a:solidFill>
                <a:latin typeface="Arial"/>
              </a:rPr>
              <a:t>Supporting Figure 3. </a:t>
            </a:r>
            <a:r>
              <a:rPr b="0" i="1" lang="en-US" sz="1500" spc="-1" strike="noStrike">
                <a:solidFill>
                  <a:srgbClr val="000000"/>
                </a:solidFill>
                <a:latin typeface="Arial"/>
              </a:rPr>
              <a:t>Ribbon presentation of Sbi-IV-C3d complex 1 superposed onto the crystal structure of the C3d-CR2 complex (Szakonyi et al., 2001) (PDB accession code: 1GHQ). The binding interface on C3d (in green) observed for Sbi-IV (complex 1, red) shows now overlap with the binding site of CR2 (the C3d binding CR2 molecule is shown in magenta). The positions of two zinc ions (Zn2+, gray) at the CR2-C3d interface are also shown.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1" name=""/>
          <p:cNvGrpSpPr/>
          <p:nvPr/>
        </p:nvGrpSpPr>
        <p:grpSpPr>
          <a:xfrm>
            <a:off x="1039680" y="63360"/>
            <a:ext cx="6629400" cy="4816080"/>
            <a:chOff x="1039680" y="63360"/>
            <a:chExt cx="6629400" cy="4816080"/>
          </a:xfrm>
        </p:grpSpPr>
        <p:pic>
          <p:nvPicPr>
            <p:cNvPr id="92" name="Picture 3" descr="model1_C3_superpos3.png"/>
            <p:cNvPicPr/>
            <p:nvPr/>
          </p:nvPicPr>
          <p:blipFill>
            <a:blip r:embed="rId1"/>
            <a:srcRect l="29584" t="0" r="30000" b="4021"/>
            <a:stretch/>
          </p:blipFill>
          <p:spPr>
            <a:xfrm>
              <a:off x="1039680" y="810000"/>
              <a:ext cx="2794320" cy="4069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3" name="Picture 5" descr="model1_C3_superpos3_zoom.png"/>
            <p:cNvPicPr/>
            <p:nvPr/>
          </p:nvPicPr>
          <p:blipFill>
            <a:blip r:embed="rId2"/>
            <a:srcRect l="10693" t="0" r="17861" b="0"/>
            <a:stretch/>
          </p:blipFill>
          <p:spPr>
            <a:xfrm>
              <a:off x="3670920" y="96840"/>
              <a:ext cx="3669120" cy="3150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4" name="TextBox 7"/>
            <p:cNvSpPr/>
            <p:nvPr/>
          </p:nvSpPr>
          <p:spPr>
            <a:xfrm>
              <a:off x="7176960" y="374040"/>
              <a:ext cx="492120" cy="640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800" spc="-1" strike="noStrike">
                  <a:solidFill>
                    <a:srgbClr val="660066"/>
                  </a:solidFill>
                  <a:latin typeface="Calibri"/>
                </a:rPr>
                <a:t>AN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TextBox 9"/>
            <p:cNvSpPr/>
            <p:nvPr/>
          </p:nvSpPr>
          <p:spPr>
            <a:xfrm>
              <a:off x="1139040" y="2968560"/>
              <a:ext cx="80388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800" spc="-1" strike="noStrike">
                  <a:solidFill>
                    <a:srgbClr val="ff0000"/>
                  </a:solidFill>
                  <a:latin typeface="Calibri"/>
                </a:rPr>
                <a:t>Sbi-IV</a:t>
              </a:r>
              <a:r>
                <a:rPr b="1" lang="en-US" sz="1800" spc="-1" strike="noStrike" baseline="30000">
                  <a:solidFill>
                    <a:srgbClr val="ff0000"/>
                  </a:solidFill>
                  <a:latin typeface="Calibri"/>
                </a:rPr>
                <a:t>1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TextBox 11"/>
            <p:cNvSpPr/>
            <p:nvPr/>
          </p:nvSpPr>
          <p:spPr>
            <a:xfrm>
              <a:off x="3218040" y="1777320"/>
              <a:ext cx="492120" cy="640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800" spc="-1" strike="noStrike">
                  <a:solidFill>
                    <a:srgbClr val="660066"/>
                  </a:solidFill>
                  <a:latin typeface="Calibri"/>
                </a:rPr>
                <a:t>AN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TextBox 12"/>
            <p:cNvSpPr/>
            <p:nvPr/>
          </p:nvSpPr>
          <p:spPr>
            <a:xfrm>
              <a:off x="3548520" y="4263840"/>
              <a:ext cx="498960" cy="457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Calibri"/>
                </a:rPr>
                <a:t>C3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TextBox 13"/>
            <p:cNvSpPr/>
            <p:nvPr/>
          </p:nvSpPr>
          <p:spPr>
            <a:xfrm>
              <a:off x="4036320" y="63360"/>
              <a:ext cx="100800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800" spc="-1" strike="noStrike">
                  <a:solidFill>
                    <a:srgbClr val="008000"/>
                  </a:solidFill>
                  <a:latin typeface="Calibri"/>
                </a:rPr>
                <a:t>C3d</a:t>
              </a: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/</a:t>
              </a:r>
              <a:r>
                <a:rPr b="1" lang="en-US" sz="1800" spc="-1" strike="noStrike">
                  <a:solidFill>
                    <a:srgbClr val="660066"/>
                  </a:solidFill>
                  <a:latin typeface="Calibri"/>
                </a:rPr>
                <a:t>TED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TextBox 14"/>
            <p:cNvSpPr/>
            <p:nvPr/>
          </p:nvSpPr>
          <p:spPr>
            <a:xfrm>
              <a:off x="4694040" y="2688840"/>
              <a:ext cx="80388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800" spc="-1" strike="noStrike">
                  <a:solidFill>
                    <a:srgbClr val="ff0000"/>
                  </a:solidFill>
                  <a:latin typeface="Calibri"/>
                </a:rPr>
                <a:t>Sbi-IV</a:t>
              </a:r>
              <a:r>
                <a:rPr b="1" lang="en-US" sz="1800" spc="-1" strike="noStrike" baseline="30000">
                  <a:solidFill>
                    <a:srgbClr val="ff0000"/>
                  </a:solidFill>
                  <a:latin typeface="Calibri"/>
                </a:rPr>
                <a:t>1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TextBox 15"/>
            <p:cNvSpPr/>
            <p:nvPr/>
          </p:nvSpPr>
          <p:spPr>
            <a:xfrm>
              <a:off x="5278680" y="3133080"/>
              <a:ext cx="64548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800" spc="-1" strike="noStrike">
                  <a:solidFill>
                    <a:srgbClr val="9c9c00"/>
                  </a:solidFill>
                  <a:latin typeface="Calibri"/>
                </a:rPr>
                <a:t>MG2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TextBox 18"/>
            <p:cNvSpPr/>
            <p:nvPr/>
          </p:nvSpPr>
          <p:spPr>
            <a:xfrm>
              <a:off x="4112280" y="2753640"/>
              <a:ext cx="30852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800000"/>
                  </a:solidFill>
                  <a:latin typeface="Calibri"/>
                  <a:ea typeface="Times New Roman"/>
                </a:rPr>
                <a:t>N</a:t>
              </a:r>
              <a:r>
                <a:rPr b="0" lang="en-GB" sz="1400" spc="-1" strike="noStrike">
                  <a:solidFill>
                    <a:srgbClr val="800000"/>
                  </a:solidFill>
                  <a:latin typeface="Calibri"/>
                </a:rPr>
                <a:t>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TextBox 16"/>
            <p:cNvSpPr/>
            <p:nvPr/>
          </p:nvSpPr>
          <p:spPr>
            <a:xfrm>
              <a:off x="1124280" y="1515960"/>
              <a:ext cx="100800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800" spc="-1" strike="noStrike">
                  <a:solidFill>
                    <a:srgbClr val="008000"/>
                  </a:solidFill>
                  <a:latin typeface="Calibri"/>
                </a:rPr>
                <a:t>C3d</a:t>
              </a: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/</a:t>
              </a:r>
              <a:r>
                <a:rPr b="1" lang="en-US" sz="1800" spc="-1" strike="noStrike">
                  <a:solidFill>
                    <a:srgbClr val="660066"/>
                  </a:solidFill>
                  <a:latin typeface="Calibri"/>
                </a:rPr>
                <a:t>TED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3" name=""/>
          <p:cNvSpPr/>
          <p:nvPr/>
        </p:nvSpPr>
        <p:spPr>
          <a:xfrm>
            <a:off x="168120" y="5195880"/>
            <a:ext cx="8825040" cy="1463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spcBef>
                <a:spcPts val="9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500" spc="-1" strike="noStrike">
                <a:solidFill>
                  <a:srgbClr val="000000"/>
                </a:solidFill>
                <a:latin typeface="Arial"/>
              </a:rPr>
              <a:t>Supporting Figure 4. </a:t>
            </a:r>
            <a:r>
              <a:rPr b="0" i="1" lang="en-US" sz="1500" spc="-1" strike="noStrike">
                <a:solidFill>
                  <a:srgbClr val="000000"/>
                </a:solidFill>
                <a:latin typeface="Arial"/>
              </a:rPr>
              <a:t>Sbi-IV-C3d complex 1 superposed onto the structure of intact C3. For this figure Sbi-IV-C3d complex 1 is superposed onto the crystal structure of intact C3</a:t>
            </a:r>
            <a:r>
              <a:rPr b="1" i="1" lang="en-US" sz="1500" spc="-1" strike="noStrike">
                <a:solidFill>
                  <a:srgbClr val="000000"/>
                </a:solidFill>
                <a:latin typeface="Arial"/>
              </a:rPr>
              <a:t>(Janssen et al., 2005) </a:t>
            </a:r>
            <a:r>
              <a:rPr b="0" i="1" lang="en-US" sz="1500" spc="-1" strike="noStrike">
                <a:solidFill>
                  <a:srgbClr val="000000"/>
                </a:solidFill>
                <a:latin typeface="Arial"/>
              </a:rPr>
              <a:t>(PDB accession code 2A73). The structural identity between C3d and C3 TED domain was used in producing the structural overlay. The ribbon diagram of the C3 </a:t>
            </a:r>
            <a:r>
              <a:rPr b="0" i="1" lang="en-US" sz="1500" spc="-1" strike="noStrike">
                <a:solidFill>
                  <a:srgbClr val="000000"/>
                </a:solidFill>
                <a:latin typeface="Symbol"/>
                <a:ea typeface="Symbol"/>
              </a:rPr>
              <a:t></a:t>
            </a:r>
            <a:r>
              <a:rPr b="0" i="1" lang="en-US" sz="1500" spc="-1" strike="noStrike">
                <a:solidFill>
                  <a:srgbClr val="000000"/>
                </a:solidFill>
                <a:latin typeface="Arial"/>
              </a:rPr>
              <a:t>-chain is shown in magenta and that of the </a:t>
            </a:r>
            <a:r>
              <a:rPr b="0" i="1" lang="en-US" sz="15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i="1" lang="en-US" sz="1500" spc="-1" strike="noStrike">
                <a:solidFill>
                  <a:srgbClr val="000000"/>
                </a:solidFill>
                <a:latin typeface="Arial"/>
              </a:rPr>
              <a:t>-chain in yellow, C3d is green and Sbi-IV is red. A close-up view of this complex is presented in the right panel.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2-11T15:24:32Z</dcterms:created>
  <dc:creator>Jean van den Elsen</dc:creator>
  <dc:description/>
  <dc:language>en-US</dc:language>
  <cp:lastModifiedBy>57524</cp:lastModifiedBy>
  <dcterms:modified xsi:type="dcterms:W3CDTF">2010-11-02T04:40:47Z</dcterms:modified>
  <cp:revision>8</cp:revision>
  <dc:subject/>
  <dc:title>Slide 1</dc:title>
</cp:coreProperties>
</file>